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59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/>
        </p14:section>
        <p14:section name="Untitled Section" id="{A2CCFE4C-EF63-491B-AD2E-AD524F6B4059}">
          <p14:sldIdLst>
            <p14:sldId id="269"/>
            <p14:sldId id="25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315BD7-D284-CC87-7D31-477E25785A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9CC836-AA88-E26B-0EB5-EEE11CC256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l" rtl="0">
              <a:lnSpc>
                <a:spcPct val="150000"/>
              </a:lnSpc>
              <a:spcAft>
                <a:spcPts val="600"/>
              </a:spcAft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Figure S2.3.</a:t>
            </a:r>
            <a:r>
              <a:rPr lang="en-US" sz="18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Three-factor confirmatory factor analysis (CFA) model for the 24-item self-reported nursing performance instrument.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Standardised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estimates are displayed. Model fit: χ²/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df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= 3.163; CFI = 0.952; TLI = 0.940; RMSEA = 0.064 (90% CI: 0.061, 0.067). All factor loadings are significant at p &lt; 0.001. CFA, confirmatory factor analysis; CFI, comparative fit index; CI, confidence interval; RMSEA, root mean square error of approximation; TLI, Tucker–Lewis index.</a:t>
            </a:r>
            <a:endParaRPr lang="en-US" sz="1800" dirty="0">
              <a:effectLst/>
              <a:latin typeface="Times New Roman" panose="02020603050405020304" pitchFamily="18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4367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1">
            <a:extLst>
              <a:ext uri="{FF2B5EF4-FFF2-40B4-BE49-F238E27FC236}">
                <a16:creationId xmlns:a16="http://schemas.microsoft.com/office/drawing/2014/main" id="{027BBF78-746B-E100-B30A-EE55A72604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7"/>
          <a:stretch>
            <a:fillRect/>
          </a:stretch>
        </p:blipFill>
        <p:spPr bwMode="auto">
          <a:xfrm>
            <a:off x="594911" y="0"/>
            <a:ext cx="7315200" cy="51214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96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8</cp:revision>
  <dcterms:created xsi:type="dcterms:W3CDTF">2026-05-06T20:22:58Z</dcterms:created>
  <dcterms:modified xsi:type="dcterms:W3CDTF">2026-05-07T01:42:37Z</dcterms:modified>
</cp:coreProperties>
</file>